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9" r:id="rId2"/>
    <p:sldId id="270" r:id="rId3"/>
    <p:sldId id="264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冀 芳芳" initials="冀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36" autoAdjust="0"/>
    <p:restoredTop sz="93553" autoAdjust="0"/>
  </p:normalViewPr>
  <p:slideViewPr>
    <p:cSldViewPr>
      <p:cViewPr>
        <p:scale>
          <a:sx n="75" d="100"/>
          <a:sy n="75" d="100"/>
        </p:scale>
        <p:origin x="-2076" y="-2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8E2613-A245-427D-9F9F-510B2899C309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306D33-7CFC-4440-A3CF-3F1237FC8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4654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306D33-7CFC-4440-A3CF-3F1237FC8DB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1586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="" xmlns:a16="http://schemas.microsoft.com/office/drawing/2014/main" id="{C50086E7-0ADA-4C4B-9F77-C74B034CD84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7624" y="172720"/>
            <a:ext cx="6455766" cy="4840457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D7CB46E-62D9-4900-94D8-A32DBF79A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9512" y="5175577"/>
            <a:ext cx="8856984" cy="1493783"/>
          </a:xfrm>
        </p:spPr>
        <p:txBody>
          <a:bodyPr>
            <a:noAutofit/>
          </a:bodyPr>
          <a:lstStyle/>
          <a:p>
            <a:pPr algn="l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SCO (Benchmarking Universal Single-Copy Orthologs) analysis of the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n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v. ‘Datonghuanghua’ transcriptome. Proportions in blue show the relative amount of complete genes (the light blue is complete and single-copy, the dark blue is complete and duplicated. ) found in each species, whereas orange and red proportions illustrate fragmented and missing genes, respectively.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merocallis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_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mbryophyt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merocalli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liopsid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merocalli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ridiplanta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the completeness assessment of transcriptome assembly using embryophyta_odb10, liliopsida_odb10 and viridiplantae_odb10 as the database. The value at the right of each bar graph is the percentage of the completeness of the transcriptome assembly, which is also the sum of single-copy and duplicated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86734EEA-A0E1-4B2B-A70F-F7E6A1D833F8}"/>
              </a:ext>
            </a:extLst>
          </p:cNvPr>
          <p:cNvSpPr txBox="1"/>
          <p:nvPr/>
        </p:nvSpPr>
        <p:spPr>
          <a:xfrm>
            <a:off x="6419701" y="152209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.00%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="" xmlns:a16="http://schemas.microsoft.com/office/drawing/2014/main" id="{0A7CB4E6-F8EC-4BD0-ABC5-D2DCDF30398E}"/>
              </a:ext>
            </a:extLst>
          </p:cNvPr>
          <p:cNvSpPr txBox="1"/>
          <p:nvPr/>
        </p:nvSpPr>
        <p:spPr>
          <a:xfrm>
            <a:off x="6433600" y="364269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.23%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="" xmlns:a16="http://schemas.microsoft.com/office/drawing/2014/main" id="{475DC536-7462-4026-A21D-E653D85C78D5}"/>
              </a:ext>
            </a:extLst>
          </p:cNvPr>
          <p:cNvSpPr txBox="1"/>
          <p:nvPr/>
        </p:nvSpPr>
        <p:spPr>
          <a:xfrm>
            <a:off x="6433600" y="259509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.09%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5718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63DFE576-B5EA-4659-A73F-F489C91AB4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693593" y="-1363507"/>
            <a:ext cx="6086900" cy="8813914"/>
          </a:xfrm>
          <a:prstGeom prst="rect">
            <a:avLst/>
          </a:prstGeom>
        </p:spPr>
      </p:pic>
      <p:sp>
        <p:nvSpPr>
          <p:cNvPr id="5" name="TextBox 1"/>
          <p:cNvSpPr txBox="1"/>
          <p:nvPr/>
        </p:nvSpPr>
        <p:spPr>
          <a:xfrm>
            <a:off x="719572" y="6047710"/>
            <a:ext cx="76328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drogram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155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erocallis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 based on 43 EST-SSR markers constructed with UPGMA. The scale is based on genetic similarity coefficient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78707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="" xmlns:a16="http://schemas.microsoft.com/office/drawing/2014/main" id="{9FCCC006-573A-4680-B8B5-BAD15EDCD189}"/>
              </a:ext>
            </a:extLst>
          </p:cNvPr>
          <p:cNvSpPr/>
          <p:nvPr/>
        </p:nvSpPr>
        <p:spPr>
          <a:xfrm>
            <a:off x="1187624" y="5661248"/>
            <a:ext cx="712879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igure </a:t>
            </a:r>
            <a:r>
              <a:rPr lang="en-US" altLang="zh-CN" sz="1400" b="1" kern="100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3</a:t>
            </a:r>
            <a:r>
              <a:rPr lang="en-US" altLang="zh-CN" sz="1400" b="1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. </a:t>
            </a:r>
            <a:r>
              <a:rPr lang="en-US" altLang="zh-CN" sz="1400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LD distribution of LD among 43 EST-SSR loci on 2 linkage groups in </a:t>
            </a:r>
            <a:r>
              <a:rPr lang="en-US" altLang="zh-CN" sz="1400" i="1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Hemerocallis</a:t>
            </a:r>
            <a:r>
              <a:rPr lang="en-US" altLang="zh-CN" sz="1400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. Each cell above the black diagonal reports the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400" i="1" kern="100" baseline="300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400" i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value of the corresponding marker pair as shown with the color code at the upper right. Each cell below the diagonal is the </a:t>
            </a:r>
            <a:r>
              <a:rPr lang="en-US" altLang="zh-CN" sz="1400" i="1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-value of the testing LD of the corresponding marker pairs as shown with the color code at the lower right.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="" xmlns:a16="http://schemas.microsoft.com/office/drawing/2014/main" id="{D3392CA7-2955-4857-870A-F1252ADEBB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1760" y="908720"/>
            <a:ext cx="4320480" cy="4320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093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2</TotalTime>
  <Words>232</Words>
  <Application>Microsoft Office PowerPoint</Application>
  <PresentationFormat>全屏显示(4:3)</PresentationFormat>
  <Paragraphs>7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Figure S1. BUSCO (Benchmarking Universal Single-Copy Orthologs) analysis of the H. citrina cv. ‘Datonghuanghua’ transcriptome. Proportions in blue show the relative amount of complete genes (the light blue is complete and single-copy, the dark blue is complete and duplicated. ) found in each species, whereas orange and red proportions illustrate fragmented and missing genes, respectively. Hemerocallis_ Embryophyte, Hemerocallis_ Liliopsida, Hemerocallis_ Viridiplantae represent the completeness assessment of transcriptome assembly using embryophyta_odb10, liliopsida_odb10 and viridiplantae_odb10 as the database. The value at the right of each bar graph is the percentage of the completeness of the transcriptome assembly, which is also the sum of single-copy and duplicated.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sen</cp:lastModifiedBy>
  <cp:revision>68</cp:revision>
  <dcterms:created xsi:type="dcterms:W3CDTF">2018-10-22T14:25:00Z</dcterms:created>
  <dcterms:modified xsi:type="dcterms:W3CDTF">2020-03-17T19:1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612</vt:lpwstr>
  </property>
</Properties>
</file>